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88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096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606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369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875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118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796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695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63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073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742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963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79538-4078-1F47-9FB2-D54BC2244DF0}" type="datetimeFigureOut">
              <a:rPr lang="en-US" smtClean="0"/>
              <a:t>7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85F1E-B1E8-D44D-980D-3A74335EF3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213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5800" y="368300"/>
            <a:ext cx="7696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Supplement Fig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2</a:t>
            </a:r>
            <a:r>
              <a:rPr lang="en-US" sz="140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Expression of poly n acetyllactosamine epitope does not effect the cell 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roliferation rate or drug sensitivity 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800603" y="3886200"/>
            <a:ext cx="3257551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2003" y="3810000"/>
            <a:ext cx="3506159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3124200" y="5115579"/>
            <a:ext cx="609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NS</a:t>
            </a:r>
          </a:p>
          <a:p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7086600" y="5267981"/>
            <a:ext cx="609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NS</a:t>
            </a:r>
          </a:p>
          <a:p>
            <a:endParaRPr lang="en-US" sz="14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057401" y="1066800"/>
            <a:ext cx="5033555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" name="TextBox 19"/>
          <p:cNvSpPr txBox="1"/>
          <p:nvPr/>
        </p:nvSpPr>
        <p:spPr>
          <a:xfrm>
            <a:off x="1828800" y="1219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685800" y="3581401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800600" y="36576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4876800" y="1371600"/>
            <a:ext cx="609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NS</a:t>
            </a:r>
          </a:p>
          <a:p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4038600" y="2057399"/>
            <a:ext cx="609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NS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7125489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8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tanfo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ia Bieber</dc:creator>
  <cp:lastModifiedBy>Marcia Bieber</cp:lastModifiedBy>
  <cp:revision>3</cp:revision>
  <dcterms:created xsi:type="dcterms:W3CDTF">2017-03-30T20:52:36Z</dcterms:created>
  <dcterms:modified xsi:type="dcterms:W3CDTF">2017-07-25T21:05:56Z</dcterms:modified>
</cp:coreProperties>
</file>